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wmf" ContentType="image/x-w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797675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39" d="100"/>
          <a:sy n="139" d="100"/>
        </p:scale>
        <p:origin x="-816" y="-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3E3139-1069-44E1-89BE-63B2F4966867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EA436B-2DAF-4208-AD15-E409C26FDF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129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EA436B-2DAF-4208-AD15-E409C26FDFDC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03716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508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7348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575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5538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6831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2648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7049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8677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2473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1916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5441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295E64-311C-4B78-B48D-81BCC105BF2D}" type="datetimeFigureOut">
              <a:rPr lang="de-DE" smtClean="0"/>
              <a:t>31.05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8F54D-C1B7-4F65-A30A-B8B8DBF316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7522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ieren 19"/>
          <p:cNvGrpSpPr/>
          <p:nvPr/>
        </p:nvGrpSpPr>
        <p:grpSpPr>
          <a:xfrm>
            <a:off x="251520" y="0"/>
            <a:ext cx="7331857" cy="6858000"/>
            <a:chOff x="251520" y="0"/>
            <a:chExt cx="7331857" cy="6858000"/>
          </a:xfrm>
        </p:grpSpPr>
        <p:cxnSp>
          <p:nvCxnSpPr>
            <p:cNvPr id="6" name="Gerade Verbindung 5"/>
            <p:cNvCxnSpPr/>
            <p:nvPr/>
          </p:nvCxnSpPr>
          <p:spPr>
            <a:xfrm>
              <a:off x="324000" y="2112023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 Verbindung 6"/>
            <p:cNvCxnSpPr/>
            <p:nvPr/>
          </p:nvCxnSpPr>
          <p:spPr>
            <a:xfrm>
              <a:off x="324000" y="776580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7"/>
            <p:cNvCxnSpPr/>
            <p:nvPr/>
          </p:nvCxnSpPr>
          <p:spPr>
            <a:xfrm>
              <a:off x="324000" y="3020704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8"/>
            <p:cNvCxnSpPr/>
            <p:nvPr/>
          </p:nvCxnSpPr>
          <p:spPr>
            <a:xfrm>
              <a:off x="324000" y="3573016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 Verbindung 9"/>
            <p:cNvCxnSpPr/>
            <p:nvPr/>
          </p:nvCxnSpPr>
          <p:spPr>
            <a:xfrm>
              <a:off x="324000" y="4359166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feld 10"/>
            <p:cNvSpPr txBox="1"/>
            <p:nvPr/>
          </p:nvSpPr>
          <p:spPr>
            <a:xfrm>
              <a:off x="251520" y="1249015"/>
              <a:ext cx="15121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idative stress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251520" y="2401143"/>
              <a:ext cx="1512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poptosis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51520" y="3019952"/>
              <a:ext cx="19442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ycle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rrest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&amp;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liferation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51520" y="3693280"/>
              <a:ext cx="17198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actors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amp;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eedback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51520" y="4725144"/>
              <a:ext cx="1647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NA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amage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amp;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air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Gerade Verbindung 17"/>
            <p:cNvCxnSpPr/>
            <p:nvPr/>
          </p:nvCxnSpPr>
          <p:spPr>
            <a:xfrm>
              <a:off x="323528" y="5697666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Grafik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0622" y="0"/>
              <a:ext cx="6022755" cy="6858000"/>
            </a:xfrm>
            <a:prstGeom prst="rect">
              <a:avLst/>
            </a:prstGeom>
          </p:spPr>
        </p:pic>
      </p:grpSp>
      <p:sp>
        <p:nvSpPr>
          <p:cNvPr id="19" name="Textfeld 18"/>
          <p:cNvSpPr txBox="1"/>
          <p:nvPr/>
        </p:nvSpPr>
        <p:spPr>
          <a:xfrm>
            <a:off x="6805724" y="1050181"/>
            <a:ext cx="2338276" cy="4262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: </a:t>
            </a:r>
          </a:p>
          <a:p>
            <a:pPr>
              <a:spcBef>
                <a:spcPts val="600"/>
              </a:spcBef>
            </a:pP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mpact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PDE on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xidative stress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rest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NA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mag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NA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air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K6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BPDE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1 h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llow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23 h post-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ubatio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hown are linear fold changes of the relative gene expression from mean values of four determinations derived from two independent experiments ± SD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481354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Macintosh PowerPoint</Application>
  <PresentationFormat>Bildschirmpräsentation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tty</dc:creator>
  <cp:lastModifiedBy>Andrea Hartwig</cp:lastModifiedBy>
  <cp:revision>9</cp:revision>
  <cp:lastPrinted>2017-04-24T13:08:11Z</cp:lastPrinted>
  <dcterms:created xsi:type="dcterms:W3CDTF">2017-04-24T12:28:42Z</dcterms:created>
  <dcterms:modified xsi:type="dcterms:W3CDTF">2017-05-31T09:43:05Z</dcterms:modified>
</cp:coreProperties>
</file>